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7559675" cy="1069181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7628" autoAdjust="0"/>
    <p:restoredTop sz="94660"/>
  </p:normalViewPr>
  <p:slideViewPr>
    <p:cSldViewPr snapToGrid="0">
      <p:cViewPr>
        <p:scale>
          <a:sx n="39" d="100"/>
          <a:sy n="39" d="100"/>
        </p:scale>
        <p:origin x="2718" y="26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976" y="1749795"/>
            <a:ext cx="6425724" cy="3722335"/>
          </a:xfrm>
        </p:spPr>
        <p:txBody>
          <a:bodyPr anchor="b"/>
          <a:lstStyle>
            <a:lvl1pPr algn="ctr">
              <a:defRPr sz="496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4960" y="5615678"/>
            <a:ext cx="5669756" cy="2581379"/>
          </a:xfrm>
        </p:spPr>
        <p:txBody>
          <a:bodyPr/>
          <a:lstStyle>
            <a:lvl1pPr marL="0" indent="0" algn="ctr">
              <a:buNone/>
              <a:defRPr sz="1984"/>
            </a:lvl1pPr>
            <a:lvl2pPr marL="377967" indent="0" algn="ctr">
              <a:buNone/>
              <a:defRPr sz="1653"/>
            </a:lvl2pPr>
            <a:lvl3pPr marL="755934" indent="0" algn="ctr">
              <a:buNone/>
              <a:defRPr sz="1488"/>
            </a:lvl3pPr>
            <a:lvl4pPr marL="1133902" indent="0" algn="ctr">
              <a:buNone/>
              <a:defRPr sz="1323"/>
            </a:lvl4pPr>
            <a:lvl5pPr marL="1511869" indent="0" algn="ctr">
              <a:buNone/>
              <a:defRPr sz="1323"/>
            </a:lvl5pPr>
            <a:lvl6pPr marL="1889836" indent="0" algn="ctr">
              <a:buNone/>
              <a:defRPr sz="1323"/>
            </a:lvl6pPr>
            <a:lvl7pPr marL="2267803" indent="0" algn="ctr">
              <a:buNone/>
              <a:defRPr sz="1323"/>
            </a:lvl7pPr>
            <a:lvl8pPr marL="2645771" indent="0" algn="ctr">
              <a:buNone/>
              <a:defRPr sz="1323"/>
            </a:lvl8pPr>
            <a:lvl9pPr marL="3023738" indent="0" algn="ctr">
              <a:buNone/>
              <a:defRPr sz="1323"/>
            </a:lvl9pPr>
          </a:lstStyle>
          <a:p>
            <a:r>
              <a:rPr lang="de-DE" smtClean="0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7B11D0-D325-4747-A3B5-3F6FFC100313}" type="datetimeFigureOut">
              <a:rPr lang="de-DE" smtClean="0"/>
              <a:t>12.04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80C5C5-B83D-4BFF-A1D2-405785DBE2D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030330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7B11D0-D325-4747-A3B5-3F6FFC100313}" type="datetimeFigureOut">
              <a:rPr lang="de-DE" smtClean="0"/>
              <a:t>12.04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80C5C5-B83D-4BFF-A1D2-405785DBE2D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884863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09893" y="569240"/>
            <a:ext cx="1630055" cy="9060817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728" y="569240"/>
            <a:ext cx="4795669" cy="9060817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7B11D0-D325-4747-A3B5-3F6FFC100313}" type="datetimeFigureOut">
              <a:rPr lang="de-DE" smtClean="0"/>
              <a:t>12.04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80C5C5-B83D-4BFF-A1D2-405785DBE2D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779407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7B11D0-D325-4747-A3B5-3F6FFC100313}" type="datetimeFigureOut">
              <a:rPr lang="de-DE" smtClean="0"/>
              <a:t>12.04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80C5C5-B83D-4BFF-A1D2-405785DBE2D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007938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791" y="2665532"/>
            <a:ext cx="6520220" cy="4447496"/>
          </a:xfrm>
        </p:spPr>
        <p:txBody>
          <a:bodyPr anchor="b"/>
          <a:lstStyle>
            <a:lvl1pPr>
              <a:defRPr sz="496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791" y="7155103"/>
            <a:ext cx="6520220" cy="2338833"/>
          </a:xfrm>
        </p:spPr>
        <p:txBody>
          <a:bodyPr/>
          <a:lstStyle>
            <a:lvl1pPr marL="0" indent="0">
              <a:buNone/>
              <a:defRPr sz="1984">
                <a:solidFill>
                  <a:schemeClr val="tx1"/>
                </a:solidFill>
              </a:defRPr>
            </a:lvl1pPr>
            <a:lvl2pPr marL="377967" indent="0">
              <a:buNone/>
              <a:defRPr sz="1653">
                <a:solidFill>
                  <a:schemeClr val="tx1">
                    <a:tint val="75000"/>
                  </a:schemeClr>
                </a:solidFill>
              </a:defRPr>
            </a:lvl2pPr>
            <a:lvl3pPr marL="755934" indent="0">
              <a:buNone/>
              <a:defRPr sz="1488">
                <a:solidFill>
                  <a:schemeClr val="tx1">
                    <a:tint val="75000"/>
                  </a:schemeClr>
                </a:solidFill>
              </a:defRPr>
            </a:lvl3pPr>
            <a:lvl4pPr marL="1133902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4pPr>
            <a:lvl5pPr marL="1511869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5pPr>
            <a:lvl6pPr marL="1889836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6pPr>
            <a:lvl7pPr marL="2267803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7pPr>
            <a:lvl8pPr marL="2645771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8pPr>
            <a:lvl9pPr marL="3023738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7B11D0-D325-4747-A3B5-3F6FFC100313}" type="datetimeFigureOut">
              <a:rPr lang="de-DE" smtClean="0"/>
              <a:t>12.04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80C5C5-B83D-4BFF-A1D2-405785DBE2D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887909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728" y="2846200"/>
            <a:ext cx="3212862" cy="6783857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7085" y="2846200"/>
            <a:ext cx="3212862" cy="6783857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7B11D0-D325-4747-A3B5-3F6FFC100313}" type="datetimeFigureOut">
              <a:rPr lang="de-DE" smtClean="0"/>
              <a:t>12.04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80C5C5-B83D-4BFF-A1D2-405785DBE2D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065163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569242"/>
            <a:ext cx="6520220" cy="2066590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713" y="2620980"/>
            <a:ext cx="3198096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713" y="3905482"/>
            <a:ext cx="3198096" cy="5744375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7086" y="2620980"/>
            <a:ext cx="3213847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7086" y="3905482"/>
            <a:ext cx="3213847" cy="5744375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7B11D0-D325-4747-A3B5-3F6FFC100313}" type="datetimeFigureOut">
              <a:rPr lang="de-DE" smtClean="0"/>
              <a:t>12.04.2024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80C5C5-B83D-4BFF-A1D2-405785DBE2D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625777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7B11D0-D325-4747-A3B5-3F6FFC100313}" type="datetimeFigureOut">
              <a:rPr lang="de-DE" smtClean="0"/>
              <a:t>12.04.2024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80C5C5-B83D-4BFF-A1D2-405785DBE2D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569979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7B11D0-D325-4747-A3B5-3F6FFC100313}" type="datetimeFigureOut">
              <a:rPr lang="de-DE" smtClean="0"/>
              <a:t>12.04.2024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80C5C5-B83D-4BFF-A1D2-405785DBE2D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550232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3847" y="1539425"/>
            <a:ext cx="3827085" cy="7598117"/>
          </a:xfrm>
        </p:spPr>
        <p:txBody>
          <a:bodyPr/>
          <a:lstStyle>
            <a:lvl1pPr>
              <a:defRPr sz="2645"/>
            </a:lvl1pPr>
            <a:lvl2pPr>
              <a:defRPr sz="2315"/>
            </a:lvl2pPr>
            <a:lvl3pPr>
              <a:defRPr sz="1984"/>
            </a:lvl3pPr>
            <a:lvl4pPr>
              <a:defRPr sz="1653"/>
            </a:lvl4pPr>
            <a:lvl5pPr>
              <a:defRPr sz="1653"/>
            </a:lvl5pPr>
            <a:lvl6pPr>
              <a:defRPr sz="1653"/>
            </a:lvl6pPr>
            <a:lvl7pPr>
              <a:defRPr sz="1653"/>
            </a:lvl7pPr>
            <a:lvl8pPr>
              <a:defRPr sz="1653"/>
            </a:lvl8pPr>
            <a:lvl9pPr>
              <a:defRPr sz="1653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7B11D0-D325-4747-A3B5-3F6FFC100313}" type="datetimeFigureOut">
              <a:rPr lang="de-DE" smtClean="0"/>
              <a:t>12.04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80C5C5-B83D-4BFF-A1D2-405785DBE2D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528065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3847" y="1539425"/>
            <a:ext cx="3827085" cy="7598117"/>
          </a:xfrm>
        </p:spPr>
        <p:txBody>
          <a:bodyPr anchor="t"/>
          <a:lstStyle>
            <a:lvl1pPr marL="0" indent="0">
              <a:buNone/>
              <a:defRPr sz="2645"/>
            </a:lvl1pPr>
            <a:lvl2pPr marL="377967" indent="0">
              <a:buNone/>
              <a:defRPr sz="2315"/>
            </a:lvl2pPr>
            <a:lvl3pPr marL="755934" indent="0">
              <a:buNone/>
              <a:defRPr sz="1984"/>
            </a:lvl3pPr>
            <a:lvl4pPr marL="1133902" indent="0">
              <a:buNone/>
              <a:defRPr sz="1653"/>
            </a:lvl4pPr>
            <a:lvl5pPr marL="1511869" indent="0">
              <a:buNone/>
              <a:defRPr sz="1653"/>
            </a:lvl5pPr>
            <a:lvl6pPr marL="1889836" indent="0">
              <a:buNone/>
              <a:defRPr sz="1653"/>
            </a:lvl6pPr>
            <a:lvl7pPr marL="2267803" indent="0">
              <a:buNone/>
              <a:defRPr sz="1653"/>
            </a:lvl7pPr>
            <a:lvl8pPr marL="2645771" indent="0">
              <a:buNone/>
              <a:defRPr sz="1653"/>
            </a:lvl8pPr>
            <a:lvl9pPr marL="3023738" indent="0">
              <a:buNone/>
              <a:defRPr sz="1653"/>
            </a:lvl9pPr>
          </a:lstStyle>
          <a:p>
            <a:r>
              <a:rPr lang="de-DE" smtClean="0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7B11D0-D325-4747-A3B5-3F6FFC100313}" type="datetimeFigureOut">
              <a:rPr lang="de-DE" smtClean="0"/>
              <a:t>12.04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80C5C5-B83D-4BFF-A1D2-405785DBE2D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123962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728" y="569242"/>
            <a:ext cx="6520220" cy="206659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728" y="2846200"/>
            <a:ext cx="6520220" cy="678385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728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7B11D0-D325-4747-A3B5-3F6FFC100313}" type="datetimeFigureOut">
              <a:rPr lang="de-DE" smtClean="0"/>
              <a:t>12.04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4143" y="9909729"/>
            <a:ext cx="2551390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39020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80C5C5-B83D-4BFF-A1D2-405785DBE2D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703720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55934" rtl="0" eaLnBrk="1" latinLnBrk="0" hangingPunct="1">
        <a:lnSpc>
          <a:spcPct val="90000"/>
        </a:lnSpc>
        <a:spcBef>
          <a:spcPct val="0"/>
        </a:spcBef>
        <a:buNone/>
        <a:defRPr sz="363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8984" indent="-188984" algn="l" defTabSz="755934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315" kern="1200">
          <a:solidFill>
            <a:schemeClr val="tx1"/>
          </a:solidFill>
          <a:latin typeface="+mn-lt"/>
          <a:ea typeface="+mn-ea"/>
          <a:cs typeface="+mn-cs"/>
        </a:defRPr>
      </a:lvl1pPr>
      <a:lvl2pPr marL="566951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944918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653" kern="1200">
          <a:solidFill>
            <a:schemeClr val="tx1"/>
          </a:solidFill>
          <a:latin typeface="+mn-lt"/>
          <a:ea typeface="+mn-ea"/>
          <a:cs typeface="+mn-cs"/>
        </a:defRPr>
      </a:lvl3pPr>
      <a:lvl4pPr marL="1322885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700853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2078820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456787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834754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212722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1pPr>
      <a:lvl2pPr marL="377967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2pPr>
      <a:lvl3pPr marL="755934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3pPr>
      <a:lvl4pPr marL="1133902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511869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1889836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267803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645771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023738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18" Type="http://schemas.openxmlformats.org/officeDocument/2006/relationships/image" Target="../media/image17.png"/><Relationship Id="rId3" Type="http://schemas.openxmlformats.org/officeDocument/2006/relationships/image" Target="../media/image2.png"/><Relationship Id="rId21" Type="http://schemas.openxmlformats.org/officeDocument/2006/relationships/image" Target="../media/image20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5" Type="http://schemas.openxmlformats.org/officeDocument/2006/relationships/image" Target="../media/image24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20" Type="http://schemas.openxmlformats.org/officeDocument/2006/relationships/image" Target="../media/image19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eg"/><Relationship Id="rId11" Type="http://schemas.openxmlformats.org/officeDocument/2006/relationships/image" Target="../media/image10.png"/><Relationship Id="rId24" Type="http://schemas.openxmlformats.org/officeDocument/2006/relationships/image" Target="../media/image23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23" Type="http://schemas.openxmlformats.org/officeDocument/2006/relationships/image" Target="../media/image22.png"/><Relationship Id="rId10" Type="http://schemas.openxmlformats.org/officeDocument/2006/relationships/image" Target="../media/image9.png"/><Relationship Id="rId19" Type="http://schemas.openxmlformats.org/officeDocument/2006/relationships/image" Target="../media/image18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Relationship Id="rId22" Type="http://schemas.openxmlformats.org/officeDocument/2006/relationships/image" Target="../media/image2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37581" y="1491805"/>
            <a:ext cx="4428000" cy="2701832"/>
          </a:xfrm>
          <a:prstGeom prst="rect">
            <a:avLst/>
          </a:prstGeom>
        </p:spPr>
      </p:pic>
      <p:pic>
        <p:nvPicPr>
          <p:cNvPr id="5" name="Grafik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37581" y="4583437"/>
            <a:ext cx="4428000" cy="2701832"/>
          </a:xfrm>
          <a:prstGeom prst="rect">
            <a:avLst/>
          </a:prstGeom>
        </p:spPr>
      </p:pic>
      <p:pic>
        <p:nvPicPr>
          <p:cNvPr id="6" name="Grafik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37581" y="7678116"/>
            <a:ext cx="4428000" cy="2701832"/>
          </a:xfrm>
          <a:prstGeom prst="rect">
            <a:avLst/>
          </a:prstGeom>
        </p:spPr>
      </p:pic>
      <p:pic>
        <p:nvPicPr>
          <p:cNvPr id="7" name="Grafik 6"/>
          <p:cNvPicPr>
            <a:picLocks noChangeAspect="1"/>
          </p:cNvPicPr>
          <p:nvPr/>
        </p:nvPicPr>
        <p:blipFill rotWithShape="1">
          <a:blip r:embed="rId3"/>
          <a:srcRect b="91310"/>
          <a:stretch/>
        </p:blipFill>
        <p:spPr>
          <a:xfrm>
            <a:off x="2189491" y="1784728"/>
            <a:ext cx="3324179" cy="196209"/>
          </a:xfrm>
          <a:prstGeom prst="rect">
            <a:avLst/>
          </a:prstGeom>
        </p:spPr>
      </p:pic>
      <p:sp>
        <p:nvSpPr>
          <p:cNvPr id="9" name="Rechteck 8"/>
          <p:cNvSpPr/>
          <p:nvPr/>
        </p:nvSpPr>
        <p:spPr>
          <a:xfrm>
            <a:off x="2430552" y="1986691"/>
            <a:ext cx="2842056" cy="856030"/>
          </a:xfrm>
          <a:prstGeom prst="rect">
            <a:avLst/>
          </a:prstGeom>
          <a:solidFill>
            <a:srgbClr val="EDFBF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3829" noProof="1"/>
          </a:p>
        </p:txBody>
      </p:sp>
      <p:pic>
        <p:nvPicPr>
          <p:cNvPr id="10" name="Grafik 9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91032" y="2305708"/>
            <a:ext cx="1921095" cy="217995"/>
          </a:xfrm>
          <a:prstGeom prst="rect">
            <a:avLst/>
          </a:prstGeom>
        </p:spPr>
      </p:pic>
      <p:sp>
        <p:nvSpPr>
          <p:cNvPr id="11" name="Rechteck 10"/>
          <p:cNvSpPr/>
          <p:nvPr/>
        </p:nvSpPr>
        <p:spPr>
          <a:xfrm>
            <a:off x="2729480" y="2187851"/>
            <a:ext cx="2172426" cy="65401"/>
          </a:xfrm>
          <a:prstGeom prst="rect">
            <a:avLst/>
          </a:prstGeom>
          <a:solidFill>
            <a:srgbClr val="EDFBF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de-DE" sz="900" b="1" noProof="1" smtClean="0">
                <a:solidFill>
                  <a:srgbClr val="020044"/>
                </a:solidFill>
                <a:latin typeface="Constantia" panose="02030602050306030303" pitchFamily="18" charset="0"/>
              </a:rPr>
              <a:t>What did your answers reveal? </a:t>
            </a:r>
          </a:p>
          <a:p>
            <a:endParaRPr lang="de-DE" sz="1914" b="1" noProof="1">
              <a:solidFill>
                <a:srgbClr val="020044"/>
              </a:solidFill>
              <a:latin typeface="Constantia" panose="02030602050306030303" pitchFamily="18" charset="0"/>
            </a:endParaRPr>
          </a:p>
        </p:txBody>
      </p:sp>
      <p:sp>
        <p:nvSpPr>
          <p:cNvPr id="12" name="Rechteck 11"/>
          <p:cNvSpPr/>
          <p:nvPr/>
        </p:nvSpPr>
        <p:spPr>
          <a:xfrm>
            <a:off x="2729480" y="2033393"/>
            <a:ext cx="2603157" cy="37374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de-DE" sz="400" noProof="1" smtClean="0">
                <a:solidFill>
                  <a:srgbClr val="020044"/>
                </a:solidFill>
                <a:ea typeface="Inter" panose="020B0502030000000004" pitchFamily="34" charset="0"/>
                <a:cs typeface="Times New Roman" panose="02020603050405020304" pitchFamily="18" charset="0"/>
              </a:rPr>
              <a:t>You have indicated that you have felt affected by some symptoms during the past two weeks.</a:t>
            </a:r>
            <a:br>
              <a:rPr lang="de-DE" sz="400" noProof="1" smtClean="0">
                <a:solidFill>
                  <a:srgbClr val="020044"/>
                </a:solidFill>
                <a:ea typeface="Inter" panose="020B0502030000000004" pitchFamily="34" charset="0"/>
                <a:cs typeface="Times New Roman" panose="02020603050405020304" pitchFamily="18" charset="0"/>
              </a:rPr>
            </a:br>
            <a:r>
              <a:rPr lang="de-DE" sz="400" noProof="1" smtClean="0">
                <a:solidFill>
                  <a:srgbClr val="020044"/>
                </a:solidFill>
                <a:ea typeface="Inter" panose="020B0502030000000004" pitchFamily="34" charset="0"/>
                <a:cs typeface="Times New Roman" panose="02020603050405020304" pitchFamily="18" charset="0"/>
              </a:rPr>
              <a:t>According to our </a:t>
            </a:r>
            <a:r>
              <a:rPr lang="de-DE" sz="400" b="1" noProof="1" smtClean="0">
                <a:solidFill>
                  <a:srgbClr val="4FC3B0"/>
                </a:solidFill>
                <a:ea typeface="Inter" panose="020B0502030000000004" pitchFamily="34" charset="0"/>
                <a:cs typeface="Times New Roman" panose="02020603050405020304" pitchFamily="18" charset="0"/>
              </a:rPr>
              <a:t>evaluation* </a:t>
            </a:r>
            <a:r>
              <a:rPr lang="de-DE" sz="400" noProof="1" smtClean="0">
                <a:solidFill>
                  <a:srgbClr val="020044"/>
                </a:solidFill>
                <a:ea typeface="Inter" panose="020B0502030000000004" pitchFamily="34" charset="0"/>
                <a:cs typeface="Times New Roman" panose="02020603050405020304" pitchFamily="18" charset="0"/>
              </a:rPr>
              <a:t>these are  </a:t>
            </a:r>
            <a:endParaRPr lang="de-DE" sz="400" noProof="1">
              <a:solidFill>
                <a:srgbClr val="020044"/>
              </a:solidFill>
              <a:ea typeface="Inter" panose="020B0502030000000004" pitchFamily="34" charset="0"/>
              <a:cs typeface="Times New Roman" panose="02020603050405020304" pitchFamily="18" charset="0"/>
            </a:endParaRPr>
          </a:p>
        </p:txBody>
      </p:sp>
      <p:sp>
        <p:nvSpPr>
          <p:cNvPr id="13" name="Textfeld 12"/>
          <p:cNvSpPr txBox="1"/>
          <p:nvPr/>
        </p:nvSpPr>
        <p:spPr>
          <a:xfrm>
            <a:off x="2891032" y="2305166"/>
            <a:ext cx="60440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400" b="1" noProof="1" smtClean="0">
                <a:solidFill>
                  <a:srgbClr val="020044"/>
                </a:solidFill>
              </a:rPr>
              <a:t>no depressive symptoms</a:t>
            </a:r>
            <a:endParaRPr lang="de-DE" sz="400" b="1" noProof="1">
              <a:solidFill>
                <a:srgbClr val="020044"/>
              </a:solidFill>
            </a:endParaRPr>
          </a:p>
        </p:txBody>
      </p:sp>
      <p:sp>
        <p:nvSpPr>
          <p:cNvPr id="14" name="Textfeld 13"/>
          <p:cNvSpPr txBox="1"/>
          <p:nvPr/>
        </p:nvSpPr>
        <p:spPr>
          <a:xfrm>
            <a:off x="3438767" y="2308259"/>
            <a:ext cx="75385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400" b="1" noProof="1" smtClean="0">
                <a:solidFill>
                  <a:srgbClr val="020044"/>
                </a:solidFill>
              </a:rPr>
              <a:t>moderate depressive symptoms</a:t>
            </a:r>
            <a:endParaRPr lang="de-DE" sz="400" b="1" noProof="1">
              <a:solidFill>
                <a:srgbClr val="020044"/>
              </a:solidFill>
            </a:endParaRPr>
          </a:p>
        </p:txBody>
      </p:sp>
      <p:sp>
        <p:nvSpPr>
          <p:cNvPr id="15" name="Textfeld 14"/>
          <p:cNvSpPr txBox="1"/>
          <p:nvPr/>
        </p:nvSpPr>
        <p:spPr>
          <a:xfrm>
            <a:off x="4192618" y="2308259"/>
            <a:ext cx="67457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400" b="1" noProof="1" smtClean="0">
                <a:solidFill>
                  <a:srgbClr val="020044"/>
                </a:solidFill>
              </a:rPr>
              <a:t>    significant  depressive symptoms</a:t>
            </a:r>
            <a:endParaRPr lang="de-DE" sz="400" b="1" noProof="1">
              <a:solidFill>
                <a:srgbClr val="020044"/>
              </a:solidFill>
            </a:endParaRPr>
          </a:p>
        </p:txBody>
      </p:sp>
      <p:sp>
        <p:nvSpPr>
          <p:cNvPr id="17" name="Textfeld 16"/>
          <p:cNvSpPr txBox="1"/>
          <p:nvPr/>
        </p:nvSpPr>
        <p:spPr>
          <a:xfrm>
            <a:off x="2729480" y="2523161"/>
            <a:ext cx="2082647" cy="215444"/>
          </a:xfrm>
          <a:prstGeom prst="rect">
            <a:avLst/>
          </a:prstGeom>
          <a:solidFill>
            <a:srgbClr val="EDFBF9"/>
          </a:solidFill>
        </p:spPr>
        <p:txBody>
          <a:bodyPr wrap="square" rtlCol="0">
            <a:spAutoFit/>
          </a:bodyPr>
          <a:lstStyle/>
          <a:p>
            <a:r>
              <a:rPr lang="de-DE" sz="400" noProof="1" smtClean="0">
                <a:solidFill>
                  <a:srgbClr val="020044"/>
                </a:solidFill>
                <a:ea typeface="Inter" panose="020B0502030000000004" pitchFamily="34" charset="0"/>
              </a:rPr>
              <a:t>These symptoms are most likely indications of </a:t>
            </a:r>
            <a:r>
              <a:rPr lang="de-DE" sz="400" b="1" noProof="1" smtClean="0">
                <a:solidFill>
                  <a:srgbClr val="4FC3B0"/>
                </a:solidFill>
                <a:ea typeface="Inter" panose="020B0502030000000004" pitchFamily="34" charset="0"/>
              </a:rPr>
              <a:t>depression</a:t>
            </a:r>
            <a:r>
              <a:rPr lang="de-DE" sz="400" noProof="1" smtClean="0">
                <a:solidFill>
                  <a:srgbClr val="020044"/>
                </a:solidFill>
                <a:ea typeface="Inter" panose="020B0502030000000004" pitchFamily="34" charset="0"/>
              </a:rPr>
              <a:t>. Please note that this feedback does not take the place of a thorough medical diagnosis.</a:t>
            </a:r>
            <a:endParaRPr lang="de-DE" sz="400" noProof="1">
              <a:solidFill>
                <a:srgbClr val="020044"/>
              </a:solidFill>
              <a:ea typeface="Inter" panose="020B0502030000000004" pitchFamily="34" charset="0"/>
            </a:endParaRPr>
          </a:p>
        </p:txBody>
      </p:sp>
      <p:sp>
        <p:nvSpPr>
          <p:cNvPr id="18" name="Rechteck 17"/>
          <p:cNvSpPr/>
          <p:nvPr/>
        </p:nvSpPr>
        <p:spPr>
          <a:xfrm>
            <a:off x="2729480" y="2710465"/>
            <a:ext cx="681597" cy="1384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300" noProof="1" smtClean="0">
                <a:solidFill>
                  <a:srgbClr val="020044"/>
                </a:solidFill>
              </a:rPr>
              <a:t>*The evaluation is based on the</a:t>
            </a:r>
            <a:endParaRPr lang="de-DE" sz="300" noProof="1">
              <a:solidFill>
                <a:srgbClr val="020044"/>
              </a:solidFill>
            </a:endParaRPr>
          </a:p>
        </p:txBody>
      </p:sp>
      <p:pic>
        <p:nvPicPr>
          <p:cNvPr id="19" name="Grafik 18"/>
          <p:cNvPicPr>
            <a:picLocks noChangeAspect="1"/>
          </p:cNvPicPr>
          <p:nvPr/>
        </p:nvPicPr>
        <p:blipFill rotWithShape="1">
          <a:blip r:embed="rId5"/>
          <a:srcRect l="815" t="-1" b="3317"/>
          <a:stretch/>
        </p:blipFill>
        <p:spPr>
          <a:xfrm>
            <a:off x="3314231" y="2741399"/>
            <a:ext cx="434754" cy="81369"/>
          </a:xfrm>
          <a:prstGeom prst="rect">
            <a:avLst/>
          </a:prstGeom>
        </p:spPr>
      </p:pic>
      <p:sp>
        <p:nvSpPr>
          <p:cNvPr id="20" name="Textfeld 19"/>
          <p:cNvSpPr txBox="1"/>
          <p:nvPr/>
        </p:nvSpPr>
        <p:spPr>
          <a:xfrm>
            <a:off x="2343471" y="2910579"/>
            <a:ext cx="1710771" cy="200055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r>
              <a:rPr lang="de-DE" sz="700" b="1" noProof="1" smtClean="0">
                <a:solidFill>
                  <a:srgbClr val="020044"/>
                </a:solidFill>
                <a:latin typeface="Constantia" panose="02030602050306030303" pitchFamily="18" charset="0"/>
              </a:rPr>
              <a:t>And now - what should I do first?</a:t>
            </a:r>
            <a:endParaRPr lang="de-DE" sz="700" b="1" noProof="1">
              <a:solidFill>
                <a:srgbClr val="020044"/>
              </a:solidFill>
              <a:latin typeface="Constantia" panose="02030602050306030303" pitchFamily="18" charset="0"/>
            </a:endParaRPr>
          </a:p>
        </p:txBody>
      </p:sp>
      <p:sp>
        <p:nvSpPr>
          <p:cNvPr id="21" name="Textfeld 20"/>
          <p:cNvSpPr txBox="1"/>
          <p:nvPr/>
        </p:nvSpPr>
        <p:spPr>
          <a:xfrm>
            <a:off x="2343471" y="3055878"/>
            <a:ext cx="1776673" cy="461665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r>
              <a:rPr lang="de-DE" sz="400" noProof="1" smtClean="0">
                <a:solidFill>
                  <a:srgbClr val="020044"/>
                </a:solidFill>
              </a:rPr>
              <a:t>Your symptoms are common - seeking advice helps. It is best to make an </a:t>
            </a:r>
            <a:r>
              <a:rPr lang="de-DE" sz="400" b="1" noProof="1" smtClean="0">
                <a:solidFill>
                  <a:srgbClr val="4FC3B0"/>
                </a:solidFill>
              </a:rPr>
              <a:t>appointment with your general practitioner </a:t>
            </a:r>
            <a:r>
              <a:rPr lang="de-DE" sz="400" noProof="1" smtClean="0">
                <a:solidFill>
                  <a:srgbClr val="020044"/>
                </a:solidFill>
              </a:rPr>
              <a:t>to talk about your evaluation. You can print it out and take it with you to start the conversation. Alternatively, you can also arrange an </a:t>
            </a:r>
            <a:r>
              <a:rPr lang="de-DE" sz="400" b="1" noProof="1" smtClean="0">
                <a:solidFill>
                  <a:srgbClr val="4FC3B0"/>
                </a:solidFill>
              </a:rPr>
              <a:t>initial consultation with a specialist </a:t>
            </a:r>
            <a:r>
              <a:rPr lang="de-DE" sz="400" noProof="1" smtClean="0">
                <a:solidFill>
                  <a:srgbClr val="020044"/>
                </a:solidFill>
              </a:rPr>
              <a:t>(e.g. psychotherapist) nearby: quickly and easily via the nationwide appointment service center.</a:t>
            </a:r>
            <a:endParaRPr lang="de-DE" sz="400" noProof="1">
              <a:solidFill>
                <a:srgbClr val="020044"/>
              </a:solidFill>
            </a:endParaRPr>
          </a:p>
        </p:txBody>
      </p:sp>
      <p:pic>
        <p:nvPicPr>
          <p:cNvPr id="22" name="Grafik 21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80467" y="2902265"/>
            <a:ext cx="822000" cy="781535"/>
          </a:xfrm>
          <a:prstGeom prst="rect">
            <a:avLst/>
          </a:prstGeom>
        </p:spPr>
      </p:pic>
      <p:pic>
        <p:nvPicPr>
          <p:cNvPr id="23" name="Grafik 22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420121" y="3517543"/>
            <a:ext cx="132932" cy="123919"/>
          </a:xfrm>
          <a:prstGeom prst="rect">
            <a:avLst/>
          </a:prstGeom>
        </p:spPr>
      </p:pic>
      <p:sp>
        <p:nvSpPr>
          <p:cNvPr id="24" name="Textfeld 23"/>
          <p:cNvSpPr txBox="1"/>
          <p:nvPr/>
        </p:nvSpPr>
        <p:spPr>
          <a:xfrm>
            <a:off x="2488201" y="3517543"/>
            <a:ext cx="588305" cy="14619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350" u="sng" noProof="1" smtClean="0">
                <a:solidFill>
                  <a:srgbClr val="020044"/>
                </a:solidFill>
              </a:rPr>
              <a:t>Print your feedback </a:t>
            </a:r>
            <a:endParaRPr lang="de-DE" sz="350" u="sng" noProof="1"/>
          </a:p>
        </p:txBody>
      </p:sp>
      <p:pic>
        <p:nvPicPr>
          <p:cNvPr id="25" name="Grafik 24"/>
          <p:cNvPicPr>
            <a:picLocks noChangeAspect="1"/>
          </p:cNvPicPr>
          <p:nvPr/>
        </p:nvPicPr>
        <p:blipFill rotWithShape="1">
          <a:blip r:embed="rId8"/>
          <a:srcRect b="15014"/>
          <a:stretch/>
        </p:blipFill>
        <p:spPr>
          <a:xfrm>
            <a:off x="2977594" y="3517543"/>
            <a:ext cx="156562" cy="117585"/>
          </a:xfrm>
          <a:prstGeom prst="rect">
            <a:avLst/>
          </a:prstGeom>
        </p:spPr>
      </p:pic>
      <p:sp>
        <p:nvSpPr>
          <p:cNvPr id="26" name="Textfeld 25"/>
          <p:cNvSpPr txBox="1"/>
          <p:nvPr/>
        </p:nvSpPr>
        <p:spPr>
          <a:xfrm>
            <a:off x="3059136" y="3517543"/>
            <a:ext cx="592012" cy="14619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350" u="sng" noProof="1" smtClean="0">
                <a:solidFill>
                  <a:srgbClr val="020044"/>
                </a:solidFill>
              </a:rPr>
              <a:t>Make an appointment</a:t>
            </a:r>
            <a:endParaRPr lang="de-DE" sz="350" u="sng" noProof="1"/>
          </a:p>
        </p:txBody>
      </p:sp>
      <p:pic>
        <p:nvPicPr>
          <p:cNvPr id="16" name="Grafik 15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38184" y="2298380"/>
            <a:ext cx="594844" cy="232649"/>
          </a:xfrm>
          <a:prstGeom prst="rect">
            <a:avLst/>
          </a:prstGeom>
        </p:spPr>
      </p:pic>
      <p:sp>
        <p:nvSpPr>
          <p:cNvPr id="27" name="Textfeld 26"/>
          <p:cNvSpPr txBox="1"/>
          <p:nvPr/>
        </p:nvSpPr>
        <p:spPr>
          <a:xfrm>
            <a:off x="3411077" y="4961628"/>
            <a:ext cx="2009443" cy="200055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r>
              <a:rPr lang="de-DE" sz="700" b="1" noProof="1" smtClean="0">
                <a:solidFill>
                  <a:srgbClr val="020044"/>
                </a:solidFill>
                <a:latin typeface="Constantia" panose="02030602050306030303" pitchFamily="18" charset="0"/>
              </a:rPr>
              <a:t>A brief explanation - what is depression?</a:t>
            </a:r>
            <a:endParaRPr lang="de-DE" sz="700" b="1" noProof="1">
              <a:solidFill>
                <a:srgbClr val="020044"/>
              </a:solidFill>
              <a:latin typeface="Constantia" panose="02030602050306030303" pitchFamily="18" charset="0"/>
            </a:endParaRPr>
          </a:p>
        </p:txBody>
      </p:sp>
      <p:sp>
        <p:nvSpPr>
          <p:cNvPr id="28" name="Textfeld 27"/>
          <p:cNvSpPr txBox="1"/>
          <p:nvPr/>
        </p:nvSpPr>
        <p:spPr>
          <a:xfrm>
            <a:off x="3406734" y="5107129"/>
            <a:ext cx="2004186" cy="153888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r>
              <a:rPr lang="de-DE" sz="400" noProof="1" smtClean="0">
                <a:solidFill>
                  <a:srgbClr val="020044"/>
                </a:solidFill>
              </a:rPr>
              <a:t>Depression is often underestimated at first as it can look different for everyone:</a:t>
            </a:r>
            <a:endParaRPr lang="de-DE" sz="400" noProof="1">
              <a:solidFill>
                <a:srgbClr val="020044"/>
              </a:solidFill>
            </a:endParaRPr>
          </a:p>
        </p:txBody>
      </p:sp>
      <p:sp>
        <p:nvSpPr>
          <p:cNvPr id="29" name="Textfeld 28"/>
          <p:cNvSpPr txBox="1"/>
          <p:nvPr/>
        </p:nvSpPr>
        <p:spPr>
          <a:xfrm>
            <a:off x="3409668" y="5217078"/>
            <a:ext cx="1941903" cy="400110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pPr marL="171450" indent="-171450">
              <a:buFont typeface="Arial" panose="020B0604020202020204" pitchFamily="34" charset="0"/>
              <a:buChar char="•"/>
            </a:pPr>
            <a:r>
              <a:rPr lang="de-DE" sz="400" noProof="1" smtClean="0">
                <a:solidFill>
                  <a:srgbClr val="020044"/>
                </a:solidFill>
              </a:rPr>
              <a:t>typical symptoms are </a:t>
            </a:r>
            <a:r>
              <a:rPr lang="de-DE" sz="400" b="1" noProof="1">
                <a:solidFill>
                  <a:srgbClr val="4FC3B0"/>
                </a:solidFill>
              </a:rPr>
              <a:t>a </a:t>
            </a:r>
            <a:r>
              <a:rPr lang="de-DE" sz="400" b="1" noProof="1" smtClean="0">
                <a:solidFill>
                  <a:srgbClr val="4FC3B0"/>
                </a:solidFill>
              </a:rPr>
              <a:t>lack of energy, low spirits </a:t>
            </a:r>
            <a:r>
              <a:rPr lang="de-DE" sz="400" noProof="1" smtClean="0">
                <a:solidFill>
                  <a:srgbClr val="020044"/>
                </a:solidFill>
              </a:rPr>
              <a:t>and </a:t>
            </a:r>
            <a:r>
              <a:rPr lang="de-DE" sz="400" b="1" noProof="1" smtClean="0">
                <a:solidFill>
                  <a:srgbClr val="4FC3B0"/>
                </a:solidFill>
              </a:rPr>
              <a:t>physical symptoms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de-DE" sz="400" noProof="1" smtClean="0">
                <a:solidFill>
                  <a:srgbClr val="020044"/>
                </a:solidFill>
              </a:rPr>
              <a:t>triggers are for example </a:t>
            </a:r>
            <a:r>
              <a:rPr lang="de-DE" sz="400" b="1" noProof="1" smtClean="0">
                <a:solidFill>
                  <a:srgbClr val="4FC3B0"/>
                </a:solidFill>
              </a:rPr>
              <a:t>stress, problems from the past </a:t>
            </a:r>
            <a:r>
              <a:rPr lang="de-DE" sz="400" noProof="1" smtClean="0">
                <a:solidFill>
                  <a:srgbClr val="020044"/>
                </a:solidFill>
              </a:rPr>
              <a:t>or </a:t>
            </a:r>
            <a:r>
              <a:rPr lang="de-DE" sz="400" b="1" noProof="1" smtClean="0">
                <a:solidFill>
                  <a:srgbClr val="4FC3B0"/>
                </a:solidFill>
              </a:rPr>
              <a:t>biological factors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de-DE" sz="400" noProof="1" smtClean="0">
                <a:solidFill>
                  <a:srgbClr val="020044"/>
                </a:solidFill>
              </a:rPr>
              <a:t>the symptoms can subside on their own, but without treatment they </a:t>
            </a:r>
            <a:r>
              <a:rPr lang="de-DE" sz="400" b="1" noProof="1" smtClean="0">
                <a:solidFill>
                  <a:srgbClr val="4FC3B0"/>
                </a:solidFill>
              </a:rPr>
              <a:t>often come back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de-DE" sz="400" noProof="1">
                <a:solidFill>
                  <a:srgbClr val="020044"/>
                </a:solidFill>
              </a:rPr>
              <a:t>t</a:t>
            </a:r>
            <a:r>
              <a:rPr lang="de-DE" sz="400" noProof="1" smtClean="0">
                <a:solidFill>
                  <a:srgbClr val="020044"/>
                </a:solidFill>
              </a:rPr>
              <a:t>he symptoms affect everyday life and increase the </a:t>
            </a:r>
            <a:r>
              <a:rPr lang="de-DE" sz="400" b="1" noProof="1" smtClean="0">
                <a:solidFill>
                  <a:srgbClr val="4FC3B0"/>
                </a:solidFill>
              </a:rPr>
              <a:t>risk of a physical illness</a:t>
            </a:r>
            <a:endParaRPr lang="de-DE" sz="400" b="1" noProof="1">
              <a:solidFill>
                <a:srgbClr val="4FC3B0"/>
              </a:solidFill>
            </a:endParaRPr>
          </a:p>
        </p:txBody>
      </p:sp>
      <p:sp>
        <p:nvSpPr>
          <p:cNvPr id="30" name="Textfeld 29"/>
          <p:cNvSpPr txBox="1"/>
          <p:nvPr/>
        </p:nvSpPr>
        <p:spPr>
          <a:xfrm>
            <a:off x="3495433" y="5617188"/>
            <a:ext cx="843829" cy="61555"/>
          </a:xfrm>
          <a:prstGeom prst="rect">
            <a:avLst/>
          </a:prstGeom>
          <a:solidFill>
            <a:srgbClr val="FFFFFF"/>
          </a:solidFill>
        </p:spPr>
        <p:txBody>
          <a:bodyPr wrap="square" lIns="0" tIns="0" rIns="0" bIns="0" rtlCol="0">
            <a:spAutoFit/>
          </a:bodyPr>
          <a:lstStyle/>
          <a:p>
            <a:r>
              <a:rPr lang="de-DE" sz="400" noProof="1" smtClean="0">
                <a:solidFill>
                  <a:srgbClr val="020044"/>
                </a:solidFill>
              </a:rPr>
              <a:t>More information can be found at</a:t>
            </a:r>
          </a:p>
        </p:txBody>
      </p:sp>
      <p:pic>
        <p:nvPicPr>
          <p:cNvPr id="31" name="Grafik 30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4202102" y="5595879"/>
            <a:ext cx="137160" cy="104172"/>
          </a:xfrm>
          <a:prstGeom prst="rect">
            <a:avLst/>
          </a:prstGeom>
        </p:spPr>
      </p:pic>
      <p:sp>
        <p:nvSpPr>
          <p:cNvPr id="32" name="Textfeld 31"/>
          <p:cNvSpPr txBox="1"/>
          <p:nvPr/>
        </p:nvSpPr>
        <p:spPr>
          <a:xfrm>
            <a:off x="4256415" y="5568176"/>
            <a:ext cx="601861" cy="1538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400" u="sng" noProof="1" smtClean="0">
                <a:solidFill>
                  <a:srgbClr val="292B64"/>
                </a:solidFill>
              </a:rPr>
              <a:t>www.psychenet.de</a:t>
            </a:r>
            <a:endParaRPr lang="de-DE" sz="400" u="sng" noProof="1">
              <a:solidFill>
                <a:srgbClr val="292B64"/>
              </a:solidFill>
            </a:endParaRPr>
          </a:p>
        </p:txBody>
      </p:sp>
      <p:pic>
        <p:nvPicPr>
          <p:cNvPr id="33" name="Grafik 32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2450272" y="4965059"/>
            <a:ext cx="781535" cy="781535"/>
          </a:xfrm>
          <a:prstGeom prst="rect">
            <a:avLst/>
          </a:prstGeom>
        </p:spPr>
      </p:pic>
      <p:sp>
        <p:nvSpPr>
          <p:cNvPr id="34" name="Textfeld 33"/>
          <p:cNvSpPr txBox="1"/>
          <p:nvPr/>
        </p:nvSpPr>
        <p:spPr>
          <a:xfrm>
            <a:off x="2343471" y="5792067"/>
            <a:ext cx="1736920" cy="200055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r>
              <a:rPr lang="de-DE" sz="700" b="1" noProof="1" smtClean="0">
                <a:solidFill>
                  <a:srgbClr val="020044"/>
                </a:solidFill>
                <a:latin typeface="Constantia" panose="02030602050306030303" pitchFamily="18" charset="0"/>
              </a:rPr>
              <a:t>Depression – how to treat it?</a:t>
            </a:r>
            <a:endParaRPr lang="de-DE" sz="700" b="1" noProof="1">
              <a:solidFill>
                <a:srgbClr val="020044"/>
              </a:solidFill>
              <a:latin typeface="Constantia" panose="02030602050306030303" pitchFamily="18" charset="0"/>
            </a:endParaRPr>
          </a:p>
        </p:txBody>
      </p:sp>
      <p:sp>
        <p:nvSpPr>
          <p:cNvPr id="35" name="Textfeld 34"/>
          <p:cNvSpPr txBox="1"/>
          <p:nvPr/>
        </p:nvSpPr>
        <p:spPr>
          <a:xfrm>
            <a:off x="2344234" y="5953508"/>
            <a:ext cx="1810831" cy="276999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r>
              <a:rPr lang="de-DE" sz="400" noProof="1" smtClean="0">
                <a:solidFill>
                  <a:srgbClr val="020044"/>
                </a:solidFill>
              </a:rPr>
              <a:t>There are very good treatments for depression - </a:t>
            </a:r>
            <a:r>
              <a:rPr lang="de-DE" sz="400" b="1" noProof="1" smtClean="0">
                <a:solidFill>
                  <a:srgbClr val="4FC3B0"/>
                </a:solidFill>
              </a:rPr>
              <a:t>psychotherapy</a:t>
            </a:r>
            <a:r>
              <a:rPr lang="de-DE" sz="400" noProof="1" smtClean="0">
                <a:solidFill>
                  <a:srgbClr val="020044"/>
                </a:solidFill>
              </a:rPr>
              <a:t> or medication are most effective. </a:t>
            </a:r>
            <a:r>
              <a:rPr lang="de-DE" sz="400" b="1" noProof="1" smtClean="0">
                <a:solidFill>
                  <a:srgbClr val="4FC3B0"/>
                </a:solidFill>
              </a:rPr>
              <a:t>Online therapies</a:t>
            </a:r>
            <a:r>
              <a:rPr lang="de-DE" sz="400" noProof="1" smtClean="0">
                <a:solidFill>
                  <a:srgbClr val="020044"/>
                </a:solidFill>
              </a:rPr>
              <a:t> are also readily available. Together with your health professional you can decide which treatment is best for you.</a:t>
            </a:r>
            <a:endParaRPr lang="de-DE" sz="400" noProof="1">
              <a:solidFill>
                <a:srgbClr val="020044"/>
              </a:solidFill>
            </a:endParaRPr>
          </a:p>
        </p:txBody>
      </p:sp>
      <p:sp>
        <p:nvSpPr>
          <p:cNvPr id="36" name="Textfeld 35"/>
          <p:cNvSpPr txBox="1"/>
          <p:nvPr/>
        </p:nvSpPr>
        <p:spPr>
          <a:xfrm>
            <a:off x="2345249" y="6187052"/>
            <a:ext cx="1725522" cy="276999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r>
              <a:rPr lang="de-DE" sz="400" noProof="1" smtClean="0">
                <a:solidFill>
                  <a:srgbClr val="020044"/>
                </a:solidFill>
              </a:rPr>
              <a:t>Exercise, sleep, and relaxation techniques can also help to support the therapy - </a:t>
            </a:r>
            <a:r>
              <a:rPr lang="de-DE" sz="400" b="1" noProof="1" smtClean="0">
                <a:solidFill>
                  <a:srgbClr val="4FC3B0"/>
                </a:solidFill>
              </a:rPr>
              <a:t>health courses </a:t>
            </a:r>
            <a:r>
              <a:rPr lang="de-DE" sz="400" noProof="1">
                <a:solidFill>
                  <a:srgbClr val="020044"/>
                </a:solidFill>
              </a:rPr>
              <a:t>in this field are supported by health </a:t>
            </a:r>
            <a:r>
              <a:rPr lang="de-DE" sz="400" noProof="1" smtClean="0">
                <a:solidFill>
                  <a:srgbClr val="020044"/>
                </a:solidFill>
              </a:rPr>
              <a:t>insurance companies.</a:t>
            </a:r>
            <a:endParaRPr lang="de-DE" sz="400" noProof="1">
              <a:solidFill>
                <a:srgbClr val="020044"/>
              </a:solidFill>
            </a:endParaRPr>
          </a:p>
        </p:txBody>
      </p:sp>
      <p:sp>
        <p:nvSpPr>
          <p:cNvPr id="37" name="Textfeld 36"/>
          <p:cNvSpPr txBox="1"/>
          <p:nvPr/>
        </p:nvSpPr>
        <p:spPr>
          <a:xfrm>
            <a:off x="2343471" y="6425437"/>
            <a:ext cx="1646029" cy="276999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r>
              <a:rPr lang="de-DE" sz="400" noProof="1" smtClean="0">
                <a:solidFill>
                  <a:srgbClr val="020044"/>
                </a:solidFill>
              </a:rPr>
              <a:t>Many people also benefit from </a:t>
            </a:r>
            <a:r>
              <a:rPr lang="de-DE" sz="400" b="1" noProof="1" smtClean="0">
                <a:solidFill>
                  <a:srgbClr val="4FC3B0"/>
                </a:solidFill>
              </a:rPr>
              <a:t>interaction with other affected people</a:t>
            </a:r>
            <a:r>
              <a:rPr lang="de-DE" sz="400" noProof="1" smtClean="0">
                <a:solidFill>
                  <a:srgbClr val="020044"/>
                </a:solidFill>
              </a:rPr>
              <a:t>, e.g. via self-help groups, online forums, self-help books, and discussions with friends or family.</a:t>
            </a:r>
            <a:endParaRPr lang="de-DE" sz="400" noProof="1">
              <a:solidFill>
                <a:srgbClr val="020044"/>
              </a:solidFill>
            </a:endParaRPr>
          </a:p>
        </p:txBody>
      </p:sp>
      <p:pic>
        <p:nvPicPr>
          <p:cNvPr id="38" name="Grafik 37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4375281" y="5853424"/>
            <a:ext cx="822000" cy="822000"/>
          </a:xfrm>
          <a:prstGeom prst="rect">
            <a:avLst/>
          </a:prstGeom>
        </p:spPr>
      </p:pic>
      <p:pic>
        <p:nvPicPr>
          <p:cNvPr id="39" name="Grafik 38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2231053" y="7968980"/>
            <a:ext cx="3231029" cy="1927666"/>
          </a:xfrm>
          <a:prstGeom prst="rect">
            <a:avLst/>
          </a:prstGeom>
        </p:spPr>
      </p:pic>
      <p:pic>
        <p:nvPicPr>
          <p:cNvPr id="41" name="Grafik 40"/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2818859" y="8107169"/>
            <a:ext cx="2217432" cy="203844"/>
          </a:xfrm>
          <a:prstGeom prst="rect">
            <a:avLst/>
          </a:prstGeom>
        </p:spPr>
      </p:pic>
      <p:pic>
        <p:nvPicPr>
          <p:cNvPr id="42" name="Grafik 41"/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2619796" y="8546971"/>
            <a:ext cx="542472" cy="109812"/>
          </a:xfrm>
          <a:prstGeom prst="rect">
            <a:avLst/>
          </a:prstGeom>
        </p:spPr>
      </p:pic>
      <p:pic>
        <p:nvPicPr>
          <p:cNvPr id="43" name="Grafik 42"/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3292277" y="8546971"/>
            <a:ext cx="589398" cy="112053"/>
          </a:xfrm>
          <a:prstGeom prst="rect">
            <a:avLst/>
          </a:prstGeom>
        </p:spPr>
      </p:pic>
      <p:pic>
        <p:nvPicPr>
          <p:cNvPr id="44" name="Grafik 43"/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3980362" y="8546971"/>
            <a:ext cx="486260" cy="105252"/>
          </a:xfrm>
          <a:prstGeom prst="rect">
            <a:avLst/>
          </a:prstGeom>
        </p:spPr>
      </p:pic>
      <p:pic>
        <p:nvPicPr>
          <p:cNvPr id="45" name="Grafik 44"/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4584756" y="8546971"/>
            <a:ext cx="533021" cy="162283"/>
          </a:xfrm>
          <a:prstGeom prst="rect">
            <a:avLst/>
          </a:prstGeom>
        </p:spPr>
      </p:pic>
      <p:pic>
        <p:nvPicPr>
          <p:cNvPr id="47" name="Grafik 46"/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2450272" y="8920310"/>
            <a:ext cx="1439902" cy="217444"/>
          </a:xfrm>
          <a:prstGeom prst="rect">
            <a:avLst/>
          </a:prstGeom>
        </p:spPr>
      </p:pic>
      <p:pic>
        <p:nvPicPr>
          <p:cNvPr id="48" name="Grafik 47"/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2912242" y="9101400"/>
            <a:ext cx="1001641" cy="506713"/>
          </a:xfrm>
          <a:prstGeom prst="rect">
            <a:avLst/>
          </a:prstGeom>
        </p:spPr>
      </p:pic>
      <p:pic>
        <p:nvPicPr>
          <p:cNvPr id="49" name="Grafik 48"/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2360543" y="9095437"/>
            <a:ext cx="554994" cy="554994"/>
          </a:xfrm>
          <a:prstGeom prst="rect">
            <a:avLst/>
          </a:prstGeom>
        </p:spPr>
      </p:pic>
      <p:pic>
        <p:nvPicPr>
          <p:cNvPr id="51" name="Grafik 50"/>
          <p:cNvPicPr>
            <a:picLocks noChangeAspect="1"/>
          </p:cNvPicPr>
          <p:nvPr/>
        </p:nvPicPr>
        <p:blipFill>
          <a:blip r:embed="rId22"/>
          <a:stretch>
            <a:fillRect/>
          </a:stretch>
        </p:blipFill>
        <p:spPr>
          <a:xfrm>
            <a:off x="3890174" y="9095437"/>
            <a:ext cx="556437" cy="556437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52" name="Grafik 51"/>
          <p:cNvPicPr>
            <a:picLocks noChangeAspect="1"/>
          </p:cNvPicPr>
          <p:nvPr/>
        </p:nvPicPr>
        <p:blipFill>
          <a:blip r:embed="rId23"/>
          <a:stretch>
            <a:fillRect/>
          </a:stretch>
        </p:blipFill>
        <p:spPr>
          <a:xfrm>
            <a:off x="4401598" y="9095437"/>
            <a:ext cx="949973" cy="525437"/>
          </a:xfrm>
          <a:prstGeom prst="rect">
            <a:avLst/>
          </a:prstGeom>
        </p:spPr>
      </p:pic>
      <p:pic>
        <p:nvPicPr>
          <p:cNvPr id="53" name="Grafik 52"/>
          <p:cNvPicPr>
            <a:picLocks noChangeAspect="1"/>
          </p:cNvPicPr>
          <p:nvPr/>
        </p:nvPicPr>
        <p:blipFill>
          <a:blip r:embed="rId24"/>
          <a:stretch>
            <a:fillRect/>
          </a:stretch>
        </p:blipFill>
        <p:spPr>
          <a:xfrm>
            <a:off x="3455755" y="9758249"/>
            <a:ext cx="664389" cy="122841"/>
          </a:xfrm>
          <a:prstGeom prst="rect">
            <a:avLst/>
          </a:prstGeom>
        </p:spPr>
      </p:pic>
      <p:pic>
        <p:nvPicPr>
          <p:cNvPr id="50" name="Grafik 49"/>
          <p:cNvPicPr>
            <a:picLocks noChangeAspect="1"/>
          </p:cNvPicPr>
          <p:nvPr/>
        </p:nvPicPr>
        <p:blipFill rotWithShape="1">
          <a:blip r:embed="rId25"/>
          <a:srcRect t="1" b="11580"/>
          <a:stretch/>
        </p:blipFill>
        <p:spPr>
          <a:xfrm>
            <a:off x="3201103" y="8637355"/>
            <a:ext cx="1282543" cy="1056452"/>
          </a:xfrm>
          <a:prstGeom prst="rect">
            <a:avLst/>
          </a:prstGeom>
          <a:ln>
            <a:noFill/>
          </a:ln>
          <a:effectLst>
            <a:outerShdw blurRad="190500" algn="tl" rotWithShape="0">
              <a:srgbClr val="000000">
                <a:alpha val="70000"/>
              </a:srgbClr>
            </a:outerShdw>
          </a:effectLst>
        </p:spPr>
      </p:pic>
      <p:sp>
        <p:nvSpPr>
          <p:cNvPr id="54" name="Textfeld 53"/>
          <p:cNvSpPr txBox="1"/>
          <p:nvPr/>
        </p:nvSpPr>
        <p:spPr>
          <a:xfrm>
            <a:off x="3200471" y="8655860"/>
            <a:ext cx="1201127" cy="1692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500" b="1" noProof="1" smtClean="0">
                <a:solidFill>
                  <a:srgbClr val="000043"/>
                </a:solidFill>
                <a:latin typeface="Constantia" panose="02030602050306030303" pitchFamily="18" charset="0"/>
              </a:rPr>
              <a:t>How do I find an online therapy?</a:t>
            </a:r>
            <a:endParaRPr lang="de-DE" sz="500" b="1" noProof="1">
              <a:solidFill>
                <a:srgbClr val="000043"/>
              </a:solidFill>
              <a:latin typeface="Constantia" panose="02030602050306030303" pitchFamily="18" charset="0"/>
            </a:endParaRPr>
          </a:p>
        </p:txBody>
      </p:sp>
      <p:sp>
        <p:nvSpPr>
          <p:cNvPr id="55" name="Textfeld 54"/>
          <p:cNvSpPr txBox="1"/>
          <p:nvPr/>
        </p:nvSpPr>
        <p:spPr>
          <a:xfrm>
            <a:off x="3200471" y="8776268"/>
            <a:ext cx="1225231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400" noProof="1" smtClean="0">
                <a:solidFill>
                  <a:srgbClr val="000043"/>
                </a:solidFill>
              </a:rPr>
              <a:t>With a prescription from a doctor, the following </a:t>
            </a:r>
            <a:r>
              <a:rPr lang="de-DE" sz="400" b="1" noProof="1" smtClean="0">
                <a:solidFill>
                  <a:srgbClr val="40C5B1"/>
                </a:solidFill>
              </a:rPr>
              <a:t>online therapy </a:t>
            </a:r>
            <a:r>
              <a:rPr lang="de-DE" sz="400" noProof="1" smtClean="0">
                <a:solidFill>
                  <a:srgbClr val="000043"/>
                </a:solidFill>
              </a:rPr>
              <a:t>is fully covered by all public health insurance companies:</a:t>
            </a:r>
            <a:endParaRPr lang="de-DE" sz="400" noProof="1">
              <a:solidFill>
                <a:srgbClr val="000043"/>
              </a:solidFill>
            </a:endParaRPr>
          </a:p>
        </p:txBody>
      </p:sp>
      <p:sp>
        <p:nvSpPr>
          <p:cNvPr id="56" name="Textfeld 55"/>
          <p:cNvSpPr txBox="1"/>
          <p:nvPr/>
        </p:nvSpPr>
        <p:spPr>
          <a:xfrm>
            <a:off x="3351609" y="9029032"/>
            <a:ext cx="872679" cy="153888"/>
          </a:xfrm>
          <a:prstGeom prst="rect">
            <a:avLst/>
          </a:prstGeom>
          <a:solidFill>
            <a:schemeClr val="bg1"/>
          </a:solidFill>
        </p:spPr>
        <p:txBody>
          <a:bodyPr wrap="square" lIns="36000" rtlCol="0">
            <a:spAutoFit/>
          </a:bodyPr>
          <a:lstStyle/>
          <a:p>
            <a:r>
              <a:rPr lang="de-DE" sz="400" b="1" u="sng" noProof="1" smtClean="0">
                <a:solidFill>
                  <a:srgbClr val="000043"/>
                </a:solidFill>
              </a:rPr>
              <a:t>Selfapy-Course for Depression</a:t>
            </a:r>
            <a:endParaRPr lang="de-DE" sz="400" b="1" u="sng" noProof="1">
              <a:solidFill>
                <a:srgbClr val="000043"/>
              </a:solidFill>
            </a:endParaRPr>
          </a:p>
        </p:txBody>
      </p:sp>
      <p:sp>
        <p:nvSpPr>
          <p:cNvPr id="2" name="Rechteck 1"/>
          <p:cNvSpPr/>
          <p:nvPr/>
        </p:nvSpPr>
        <p:spPr>
          <a:xfrm>
            <a:off x="514977" y="309927"/>
            <a:ext cx="6468016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R="611505" algn="just">
              <a:spcAft>
                <a:spcPts val="1200"/>
              </a:spcAft>
            </a:pPr>
            <a:r>
              <a:rPr lang="en-US" sz="1400" b="1" noProof="1" smtClean="0">
                <a:solidFill>
                  <a:srgbClr val="323232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ultimedia </a:t>
            </a:r>
            <a:r>
              <a:rPr lang="en-US" sz="1400" b="1" noProof="1" smtClean="0">
                <a:solidFill>
                  <a:srgbClr val="323232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ppendix:</a:t>
            </a:r>
            <a:r>
              <a:rPr lang="en-US" sz="1400" noProof="1" smtClean="0">
                <a:solidFill>
                  <a:srgbClr val="323232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Non-tailored feedback: All screens as displayed on the DISCOVER study website, including the layer ‘How do I find an online therapy?’ (English translation)</a:t>
            </a:r>
            <a:r>
              <a:rPr lang="en-US" sz="1400" noProof="1" smtClean="0">
                <a:solidFill>
                  <a:srgbClr val="333333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endParaRPr lang="en-US" sz="1400" noProof="1">
              <a:solidFill>
                <a:srgbClr val="333333"/>
              </a:solidFill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" name="Textfeld 58"/>
          <p:cNvSpPr txBox="1"/>
          <p:nvPr/>
        </p:nvSpPr>
        <p:spPr>
          <a:xfrm>
            <a:off x="3329655" y="9309228"/>
            <a:ext cx="872679" cy="369332"/>
          </a:xfrm>
          <a:prstGeom prst="rect">
            <a:avLst/>
          </a:prstGeom>
          <a:solidFill>
            <a:schemeClr val="bg1"/>
          </a:solidFill>
        </p:spPr>
        <p:txBody>
          <a:bodyPr wrap="square" lIns="36000" rtlCol="0">
            <a:spAutoFit/>
          </a:bodyPr>
          <a:lstStyle/>
          <a:p>
            <a:pPr>
              <a:lnSpc>
                <a:spcPct val="150000"/>
              </a:lnSpc>
            </a:pPr>
            <a:r>
              <a:rPr lang="de-DE" sz="400" b="1" u="sng" noProof="1" smtClean="0">
                <a:solidFill>
                  <a:srgbClr val="000043"/>
                </a:solidFill>
              </a:rPr>
              <a:t>MindDoc (Schön-Klinik)</a:t>
            </a:r>
          </a:p>
          <a:p>
            <a:pPr>
              <a:lnSpc>
                <a:spcPct val="150000"/>
              </a:lnSpc>
            </a:pPr>
            <a:r>
              <a:rPr lang="de-DE" sz="400" b="1" u="sng" noProof="1" smtClean="0">
                <a:solidFill>
                  <a:srgbClr val="000043"/>
                </a:solidFill>
              </a:rPr>
              <a:t>Deprexis</a:t>
            </a:r>
          </a:p>
          <a:p>
            <a:pPr>
              <a:lnSpc>
                <a:spcPct val="150000"/>
              </a:lnSpc>
            </a:pPr>
            <a:r>
              <a:rPr lang="de-DE" sz="400" b="1" u="sng" noProof="1" smtClean="0">
                <a:solidFill>
                  <a:srgbClr val="000043"/>
                </a:solidFill>
              </a:rPr>
              <a:t>HelloBetter Depression</a:t>
            </a:r>
            <a:endParaRPr lang="de-DE" sz="400" b="1" u="sng" noProof="1">
              <a:solidFill>
                <a:srgbClr val="000043"/>
              </a:solidFill>
            </a:endParaRPr>
          </a:p>
        </p:txBody>
      </p:sp>
      <p:sp>
        <p:nvSpPr>
          <p:cNvPr id="57" name="Textfeld 56"/>
          <p:cNvSpPr txBox="1"/>
          <p:nvPr/>
        </p:nvSpPr>
        <p:spPr>
          <a:xfrm>
            <a:off x="3198856" y="9146444"/>
            <a:ext cx="1226846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400" noProof="1" smtClean="0">
                <a:solidFill>
                  <a:srgbClr val="000043"/>
                </a:solidFill>
              </a:rPr>
              <a:t>Some health insurance companies also cover the cost of other </a:t>
            </a:r>
            <a:r>
              <a:rPr lang="de-DE" sz="400" b="1" noProof="1" smtClean="0">
                <a:solidFill>
                  <a:srgbClr val="40C5B1"/>
                </a:solidFill>
              </a:rPr>
              <a:t>online therapies</a:t>
            </a:r>
            <a:r>
              <a:rPr lang="de-DE" sz="400" noProof="1" smtClean="0">
                <a:solidFill>
                  <a:srgbClr val="000043"/>
                </a:solidFill>
              </a:rPr>
              <a:t>, such as:</a:t>
            </a:r>
            <a:endParaRPr lang="de-DE" sz="400" noProof="1">
              <a:solidFill>
                <a:srgbClr val="000043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52108049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430</Words>
  <Application>Microsoft Office PowerPoint</Application>
  <PresentationFormat>Benutzerdefiniert</PresentationFormat>
  <Paragraphs>31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6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8" baseType="lpstr">
      <vt:lpstr>Arial</vt:lpstr>
      <vt:lpstr>Calibri</vt:lpstr>
      <vt:lpstr>Calibri Light</vt:lpstr>
      <vt:lpstr>Constantia</vt:lpstr>
      <vt:lpstr>Inter</vt:lpstr>
      <vt:lpstr>Times New Roman</vt:lpstr>
      <vt:lpstr>Office</vt:lpstr>
      <vt:lpstr>PowerPoint-Präsentation</vt:lpstr>
    </vt:vector>
  </TitlesOfParts>
  <Company>UK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Volkmann, Marieke</dc:creator>
  <cp:lastModifiedBy>Sikorski, Franziska</cp:lastModifiedBy>
  <cp:revision>26</cp:revision>
  <dcterms:created xsi:type="dcterms:W3CDTF">2021-02-25T10:52:36Z</dcterms:created>
  <dcterms:modified xsi:type="dcterms:W3CDTF">2024-04-12T18:24:52Z</dcterms:modified>
</cp:coreProperties>
</file>